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654"/>
  </p:normalViewPr>
  <p:slideViewPr>
    <p:cSldViewPr snapToGrid="0" snapToObjects="1">
      <p:cViewPr>
        <p:scale>
          <a:sx n="145" d="100"/>
          <a:sy n="145" d="100"/>
        </p:scale>
        <p:origin x="880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461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538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194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748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771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72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22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876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844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8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225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645AC-1E41-B84D-A366-77C7726B3DFD}" type="datetimeFigureOut">
              <a:rPr lang="en-US" smtClean="0"/>
              <a:t>5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6EAA1-3AE1-C94A-B001-54F339FE05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653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Timeline&#10;&#10;Description automatically generated">
            <a:extLst>
              <a:ext uri="{FF2B5EF4-FFF2-40B4-BE49-F238E27FC236}">
                <a16:creationId xmlns:a16="http://schemas.microsoft.com/office/drawing/2014/main" id="{9A0244F8-1103-BE48-AAA3-2FE36FB81F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89529" y="975754"/>
            <a:ext cx="4385396" cy="79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9E1EE5-9AAC-4A4E-89FE-8F30F8D9E00C}"/>
              </a:ext>
            </a:extLst>
          </p:cNvPr>
          <p:cNvSpPr txBox="1"/>
          <p:nvPr/>
        </p:nvSpPr>
        <p:spPr>
          <a:xfrm>
            <a:off x="9089751" y="0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+mj-lt"/>
              </a:rPr>
              <a:t>Sup 1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B7E51A-1B44-2141-B877-9668385B44D6}"/>
              </a:ext>
            </a:extLst>
          </p:cNvPr>
          <p:cNvSpPr txBox="1"/>
          <p:nvPr/>
        </p:nvSpPr>
        <p:spPr>
          <a:xfrm>
            <a:off x="26941" y="8123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ABCB13-FE40-8A47-AA3A-581F814E9134}"/>
              </a:ext>
            </a:extLst>
          </p:cNvPr>
          <p:cNvSpPr txBox="1"/>
          <p:nvPr/>
        </p:nvSpPr>
        <p:spPr>
          <a:xfrm>
            <a:off x="26941" y="8174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5781DB-7154-1941-A4BF-BC4B42DE9EAB}"/>
              </a:ext>
            </a:extLst>
          </p:cNvPr>
          <p:cNvSpPr txBox="1"/>
          <p:nvPr/>
        </p:nvSpPr>
        <p:spPr>
          <a:xfrm>
            <a:off x="26941" y="1732730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1C5416-7930-0E4E-9689-8F8D4238713C}"/>
              </a:ext>
            </a:extLst>
          </p:cNvPr>
          <p:cNvSpPr txBox="1"/>
          <p:nvPr/>
        </p:nvSpPr>
        <p:spPr>
          <a:xfrm>
            <a:off x="4876623" y="8174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FF10160-E4F9-9140-A29F-4A59A24ACF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524" y="117027"/>
            <a:ext cx="8507554" cy="7613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439468C-96F0-F242-AE1B-7F38225722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0524" y="1864000"/>
            <a:ext cx="2698812" cy="80234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B355760-D716-CD4F-AE14-AD978FFE2D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0524" y="960065"/>
            <a:ext cx="4484623" cy="823279"/>
          </a:xfrm>
          <a:prstGeom prst="rect">
            <a:avLst/>
          </a:prstGeom>
        </p:spPr>
      </p:pic>
      <p:pic>
        <p:nvPicPr>
          <p:cNvPr id="13" name="Picture 12" descr="S10a and b.png">
            <a:extLst>
              <a:ext uri="{FF2B5EF4-FFF2-40B4-BE49-F238E27FC236}">
                <a16:creationId xmlns:a16="http://schemas.microsoft.com/office/drawing/2014/main" id="{688FC1E8-4CD7-D846-BC28-A722D22F57B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000" y="1881116"/>
            <a:ext cx="4678546" cy="82421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49B11AD-E3FE-A448-A70B-6E443BCA0224}"/>
              </a:ext>
            </a:extLst>
          </p:cNvPr>
          <p:cNvSpPr txBox="1"/>
          <p:nvPr/>
        </p:nvSpPr>
        <p:spPr>
          <a:xfrm>
            <a:off x="4579246" y="1765175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917B93F6-121A-6241-82F8-0D3DAADC3DC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0524" y="2747006"/>
            <a:ext cx="1994289" cy="81490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CA3AFD11-FC4C-0146-92D5-1B3A5CEF084B}"/>
              </a:ext>
            </a:extLst>
          </p:cNvPr>
          <p:cNvSpPr txBox="1"/>
          <p:nvPr/>
        </p:nvSpPr>
        <p:spPr>
          <a:xfrm>
            <a:off x="26941" y="2663345"/>
            <a:ext cx="2907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09DD808-D8FC-EA49-AB23-F41B8CA1E99F}"/>
              </a:ext>
            </a:extLst>
          </p:cNvPr>
          <p:cNvSpPr txBox="1"/>
          <p:nvPr/>
        </p:nvSpPr>
        <p:spPr>
          <a:xfrm>
            <a:off x="26941" y="5429559"/>
            <a:ext cx="25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J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33545E1-ABE1-B94B-A074-113C59827CA2}"/>
              </a:ext>
            </a:extLst>
          </p:cNvPr>
          <p:cNvSpPr txBox="1"/>
          <p:nvPr/>
        </p:nvSpPr>
        <p:spPr>
          <a:xfrm>
            <a:off x="3270704" y="2667151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57B5D1C1-4A17-7B4F-9F35-DA0F7DC05F9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39182" y="2801189"/>
            <a:ext cx="5992364" cy="9000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08BD667-F87D-FF42-9ED1-22B9EA7B35D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0524" y="3764775"/>
            <a:ext cx="7959246" cy="89156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A9DD92D-0583-E540-8D96-CAA1DC1F094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0524" y="4725554"/>
            <a:ext cx="5383865" cy="67206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29F9B9BE-0BE7-B641-9C66-409584878A6A}"/>
              </a:ext>
            </a:extLst>
          </p:cNvPr>
          <p:cNvSpPr txBox="1"/>
          <p:nvPr/>
        </p:nvSpPr>
        <p:spPr>
          <a:xfrm>
            <a:off x="26941" y="3535368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08B39DEB-4B05-5745-9663-914901A18B8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0524" y="5512379"/>
            <a:ext cx="9265371" cy="6840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A2F3E703-426D-9042-90E8-44EBC840A0B7}"/>
              </a:ext>
            </a:extLst>
          </p:cNvPr>
          <p:cNvSpPr txBox="1"/>
          <p:nvPr/>
        </p:nvSpPr>
        <p:spPr>
          <a:xfrm>
            <a:off x="26941" y="4553350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043CEFC-6838-7643-86BE-CE73BBB99922}"/>
              </a:ext>
            </a:extLst>
          </p:cNvPr>
          <p:cNvSpPr/>
          <p:nvPr/>
        </p:nvSpPr>
        <p:spPr>
          <a:xfrm>
            <a:off x="0" y="6292236"/>
            <a:ext cx="990600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 17: Differences in amino acid sequence between </a:t>
            </a:r>
            <a:r>
              <a:rPr lang="en-US" sz="1100" b="1" i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melanogaster </a:t>
            </a:r>
            <a:r>
              <a:rPr lang="en-US" sz="1100" b="1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bosomal paralogs. 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omega alignment of paralog pairs’ protein sequences; A) RpL22/22-like, B) RpS19a/b, C) RpS15Aa/b, D) RpL37a/b, E) RpS10a/b, F) RpS28a/b, G) RpL24/24-like, H) RpL7/7-like, I) RpS5a/b, J) RpLP0/P0-like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GB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08140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89</Words>
  <Application>Microsoft Macintosh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1</cp:revision>
  <dcterms:created xsi:type="dcterms:W3CDTF">2021-05-21T11:54:24Z</dcterms:created>
  <dcterms:modified xsi:type="dcterms:W3CDTF">2021-05-21T12:01:23Z</dcterms:modified>
</cp:coreProperties>
</file>